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1474" y="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weta%20214\Downloads\Revised%20survey%20tabl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29A8-4F06-A474-72F07CE086A5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29A8-4F06-A474-72F07CE086A5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29A8-4F06-A474-72F07CE086A5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29A8-4F06-A474-72F07CE086A5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29A8-4F06-A474-72F07CE086A5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29A8-4F06-A474-72F07CE086A5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29A8-4F06-A474-72F07CE086A5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29A8-4F06-A474-72F07CE086A5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29A8-4F06-A474-72F07CE086A5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29A8-4F06-A474-72F07CE086A5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29A8-4F06-A474-72F07CE086A5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7-29A8-4F06-A474-72F07CE086A5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9-29A8-4F06-A474-72F07CE086A5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B-29A8-4F06-A474-72F07CE086A5}"/>
              </c:ext>
            </c:extLst>
          </c:dPt>
          <c:dLbls>
            <c:dLbl>
              <c:idx val="0"/>
              <c:layout>
                <c:manualLayout>
                  <c:x val="-0.12105936740202092"/>
                  <c:y val="0.17588130650335373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FEF3E80D-5B05-4860-93CF-9BFDAE29FCE8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 </a:t>
                    </a: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A8C991D6-C129-46B9-9627-FAAB180C9385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29A8-4F06-A474-72F07CE086A5}"/>
                </c:ext>
              </c:extLst>
            </c:dLbl>
            <c:dLbl>
              <c:idx val="1"/>
              <c:layout>
                <c:manualLayout>
                  <c:x val="-0.18927582446689575"/>
                  <c:y val="-2.8604194745927031E-3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C5533CC6-34FC-4616-976F-1EF55F953075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 </a:t>
                    </a: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7D76A224-DC72-470D-BF69-6E7A513469CB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29A8-4F06-A474-72F07CE086A5}"/>
                </c:ext>
              </c:extLst>
            </c:dLbl>
            <c:dLbl>
              <c:idx val="2"/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6FF9D49C-5B06-4312-A7CA-E17D489CAADD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 </a:t>
                    </a: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E5B397EA-BF35-44F0-BA13-97E7747103F8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29A8-4F06-A474-72F07CE086A5}"/>
                </c:ext>
              </c:extLst>
            </c:dLbl>
            <c:dLbl>
              <c:idx val="3"/>
              <c:layout>
                <c:manualLayout>
                  <c:x val="0.17469319964607824"/>
                  <c:y val="-7.1864975211431911E-2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EA8DF428-1F4D-4C05-9532-2A738C43072F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 </a:t>
                    </a: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CD3BC207-535E-4C61-A76C-CBD4A03FB028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separator>. </c:separator>
              <c:extLst>
                <c:ext xmlns:c15="http://schemas.microsoft.com/office/drawing/2012/chart" uri="{CE6537A1-D6FC-4f65-9D91-7224C49458BB}">
                  <c15:layout>
                    <c:manualLayout>
                      <c:w val="0.16060315406749792"/>
                      <c:h val="0.10498687664041995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29A8-4F06-A474-72F07CE086A5}"/>
                </c:ext>
              </c:extLst>
            </c:dLbl>
            <c:dLbl>
              <c:idx val="4"/>
              <c:layout>
                <c:manualLayout>
                  <c:x val="0.10392975842608917"/>
                  <c:y val="-3.1111111111111109E-3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D86DDF82-554E-4F8D-8994-14A61F1FF2BD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 </a:t>
                    </a: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F2F0140F-5893-4D53-BDCE-37CCC626B8D8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29A8-4F06-A474-72F07CE086A5}"/>
                </c:ext>
              </c:extLst>
            </c:dLbl>
            <c:dLbl>
              <c:idx val="5"/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074A3CBA-7BFE-4FA5-A52F-0488B385D20A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 </a:t>
                    </a: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DD56AD05-B80E-4EEC-8500-17C498CEA573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29A8-4F06-A474-72F07CE086A5}"/>
                </c:ext>
              </c:extLst>
            </c:dLbl>
            <c:dLbl>
              <c:idx val="6"/>
              <c:layout>
                <c:manualLayout>
                  <c:x val="7.7746797231082618E-2"/>
                  <c:y val="-0.14630912802566345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9312202B-9698-48AF-A8CB-EEAC1C64A735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endParaRPr lang="en-US">
                      <a:solidFill>
                        <a:schemeClr val="tx1"/>
                      </a:solidFill>
                    </a:endParaRP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FD20E222-A47D-4781-9001-B1C2DBA5029E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D-29A8-4F06-A474-72F07CE086A5}"/>
                </c:ext>
              </c:extLst>
            </c:dLbl>
            <c:dLbl>
              <c:idx val="7"/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97E91755-D6C8-4BF5-AE27-75CDA12299E6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endParaRPr lang="en-US">
                      <a:solidFill>
                        <a:schemeClr val="tx1"/>
                      </a:solidFill>
                    </a:endParaRP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7B265FF5-A8BA-4E02-BAFE-1B26A986FBBB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F-29A8-4F06-A474-72F07CE086A5}"/>
                </c:ext>
              </c:extLst>
            </c:dLbl>
            <c:dLbl>
              <c:idx val="8"/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171533BA-7BB1-4B29-9A74-32D091CF7F98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endParaRPr lang="en-US">
                      <a:solidFill>
                        <a:schemeClr val="tx1"/>
                      </a:solidFill>
                    </a:endParaRP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FE0AD583-EBEE-41B9-9094-96D8B725155E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1-29A8-4F06-A474-72F07CE086A5}"/>
                </c:ext>
              </c:extLst>
            </c:dLbl>
            <c:dLbl>
              <c:idx val="9"/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F405F927-8192-46C9-A2C7-39B33AAA5246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endParaRPr lang="en-US">
                      <a:solidFill>
                        <a:schemeClr val="tx1"/>
                      </a:solidFill>
                    </a:endParaRP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71BB5AF8-3FD6-427C-8C30-2F5A62423AC8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3-29A8-4F06-A474-72F07CE086A5}"/>
                </c:ext>
              </c:extLst>
            </c:dLbl>
            <c:dLbl>
              <c:idx val="10"/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8BADE228-E1C9-44CB-ABE0-D24CC7E812EA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endParaRPr lang="en-US">
                      <a:solidFill>
                        <a:schemeClr val="tx1"/>
                      </a:solidFill>
                    </a:endParaRP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9D5431C4-4C1C-4168-87F2-3972ABCC88B4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5-29A8-4F06-A474-72F07CE086A5}"/>
                </c:ext>
              </c:extLst>
            </c:dLbl>
            <c:dLbl>
              <c:idx val="11"/>
              <c:layout>
                <c:manualLayout>
                  <c:x val="0.1397574156441454"/>
                  <c:y val="-1.9649570830673193E-4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5A5F2EA3-FF65-4F5A-9FE6-53CDDE73DD56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endParaRPr lang="en-US">
                      <a:solidFill>
                        <a:schemeClr val="tx1"/>
                      </a:solidFill>
                    </a:endParaRP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C09A95DE-665D-4DE6-A412-9E2563D8C866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7-29A8-4F06-A474-72F07CE086A5}"/>
                </c:ext>
              </c:extLst>
            </c:dLbl>
            <c:dLbl>
              <c:idx val="12"/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C46598A0-50A6-493B-9766-91B31F36ABB2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endParaRPr lang="en-US">
                      <a:solidFill>
                        <a:schemeClr val="tx1"/>
                      </a:solidFill>
                    </a:endParaRP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E8EB1618-7753-4216-8F92-C2DA69A68EEA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9-29A8-4F06-A474-72F07CE086A5}"/>
                </c:ext>
              </c:extLst>
            </c:dLbl>
            <c:dLbl>
              <c:idx val="13"/>
              <c:layout>
                <c:manualLayout>
                  <c:x val="0.1173333370509989"/>
                  <c:y val="0.17865908428113153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1" i="0" u="none" strike="noStrike" kern="1200" spc="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1BB24BEE-C97A-45C9-9CF3-C05034E6768F}" type="CATEGORYNAM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CATEGORY NAM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 </a:t>
                    </a:r>
                  </a:p>
                  <a:p>
                    <a:pPr>
                      <a:defRPr>
                        <a:solidFill>
                          <a:schemeClr val="tx1"/>
                        </a:solidFill>
                      </a:defRPr>
                    </a:pPr>
                    <a:r>
                      <a:rPr lang="en-US">
                        <a:solidFill>
                          <a:schemeClr val="tx1"/>
                        </a:solidFill>
                      </a:rPr>
                      <a:t>(</a:t>
                    </a:r>
                    <a:fld id="{2A36286A-9330-4EB5-A1DC-40C234537DB7}" type="VALUE">
                      <a:rPr lang="en-US">
                        <a:solidFill>
                          <a:schemeClr val="tx1"/>
                        </a:solidFill>
                      </a:rPr>
                      <a:pPr>
                        <a:defRPr>
                          <a:solidFill>
                            <a:schemeClr val="tx1"/>
                          </a:solidFill>
                        </a:defRPr>
                      </a:pPr>
                      <a:t>[VALUE]</a:t>
                    </a:fld>
                    <a:r>
                      <a:rPr lang="en-US">
                        <a:solidFill>
                          <a:schemeClr val="tx1"/>
                        </a:solidFill>
                      </a:rPr>
                      <a:t>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1" i="0" u="none" strike="noStrike" kern="1200" spc="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B-29A8-4F06-A474-72F07CE086A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spc="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I$5:$I$18</c:f>
              <c:strCache>
                <c:ptCount val="14"/>
                <c:pt idx="0">
                  <c:v>Bottle gourd</c:v>
                </c:pt>
                <c:pt idx="1">
                  <c:v>Bitter gourd</c:v>
                </c:pt>
                <c:pt idx="2">
                  <c:v>Sponge gourd</c:v>
                </c:pt>
                <c:pt idx="3">
                  <c:v>Snake gourd</c:v>
                </c:pt>
                <c:pt idx="4">
                  <c:v>Ridge gourd</c:v>
                </c:pt>
                <c:pt idx="5">
                  <c:v>Ivy gourd</c:v>
                </c:pt>
                <c:pt idx="6">
                  <c:v>Pumpkin</c:v>
                </c:pt>
                <c:pt idx="7">
                  <c:v>Watermelon</c:v>
                </c:pt>
                <c:pt idx="8">
                  <c:v>Muskmelon</c:v>
                </c:pt>
                <c:pt idx="9">
                  <c:v>Longmelon</c:v>
                </c:pt>
                <c:pt idx="10">
                  <c:v>Round melon</c:v>
                </c:pt>
                <c:pt idx="11">
                  <c:v>Squash</c:v>
                </c:pt>
                <c:pt idx="12">
                  <c:v>Satputia</c:v>
                </c:pt>
                <c:pt idx="13">
                  <c:v>Cucumber</c:v>
                </c:pt>
              </c:strCache>
            </c:strRef>
          </c:cat>
          <c:val>
            <c:numRef>
              <c:f>Sheet1!$J$5:$J$18</c:f>
              <c:numCache>
                <c:formatCode>General</c:formatCode>
                <c:ptCount val="14"/>
                <c:pt idx="0">
                  <c:v>105</c:v>
                </c:pt>
                <c:pt idx="1">
                  <c:v>72</c:v>
                </c:pt>
                <c:pt idx="2">
                  <c:v>74</c:v>
                </c:pt>
                <c:pt idx="3">
                  <c:v>15</c:v>
                </c:pt>
                <c:pt idx="4">
                  <c:v>7</c:v>
                </c:pt>
                <c:pt idx="5">
                  <c:v>12</c:v>
                </c:pt>
                <c:pt idx="6">
                  <c:v>62</c:v>
                </c:pt>
                <c:pt idx="7">
                  <c:v>21</c:v>
                </c:pt>
                <c:pt idx="8">
                  <c:v>10</c:v>
                </c:pt>
                <c:pt idx="9">
                  <c:v>15</c:v>
                </c:pt>
                <c:pt idx="10">
                  <c:v>7</c:v>
                </c:pt>
                <c:pt idx="11">
                  <c:v>52</c:v>
                </c:pt>
                <c:pt idx="12">
                  <c:v>6</c:v>
                </c:pt>
                <c:pt idx="13">
                  <c:v>1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29A8-4F06-A474-72F07CE086A5}"/>
            </c:ext>
          </c:extLst>
        </c:ser>
        <c:dLbls>
          <c:showLegendKey val="0"/>
          <c:showVal val="1"/>
          <c:showCatName val="1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gradFill>
                <a:gsLst>
                  <a:gs pos="100000">
                    <a:schemeClr val="accent1">
                      <a:lumMod val="60000"/>
                      <a:lumOff val="40000"/>
                    </a:schemeClr>
                  </a:gs>
                  <a:gs pos="0">
                    <a:schemeClr val="accent1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5EA-4DC9-BD33-13FC400311D4}"/>
              </c:ext>
            </c:extLst>
          </c:dPt>
          <c:dPt>
            <c:idx val="1"/>
            <c:bubble3D val="0"/>
            <c:spPr>
              <a:gradFill>
                <a:gsLst>
                  <a:gs pos="100000">
                    <a:schemeClr val="accent2">
                      <a:lumMod val="60000"/>
                      <a:lumOff val="40000"/>
                    </a:schemeClr>
                  </a:gs>
                  <a:gs pos="0">
                    <a:schemeClr val="accent2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5EA-4DC9-BD33-13FC400311D4}"/>
              </c:ext>
            </c:extLst>
          </c:dPt>
          <c:dPt>
            <c:idx val="2"/>
            <c:bubble3D val="0"/>
            <c:spPr>
              <a:gradFill>
                <a:gsLst>
                  <a:gs pos="100000">
                    <a:schemeClr val="accent3">
                      <a:lumMod val="60000"/>
                      <a:lumOff val="40000"/>
                    </a:schemeClr>
                  </a:gs>
                  <a:gs pos="0">
                    <a:schemeClr val="accent3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5EA-4DC9-BD33-13FC400311D4}"/>
              </c:ext>
            </c:extLst>
          </c:dPt>
          <c:dPt>
            <c:idx val="3"/>
            <c:bubble3D val="0"/>
            <c:spPr>
              <a:gradFill>
                <a:gsLst>
                  <a:gs pos="100000">
                    <a:schemeClr val="accent4">
                      <a:lumMod val="60000"/>
                      <a:lumOff val="40000"/>
                    </a:schemeClr>
                  </a:gs>
                  <a:gs pos="0">
                    <a:schemeClr val="accent4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5EA-4DC9-BD33-13FC400311D4}"/>
              </c:ext>
            </c:extLst>
          </c:dPt>
          <c:dPt>
            <c:idx val="4"/>
            <c:bubble3D val="0"/>
            <c:spPr>
              <a:gradFill>
                <a:gsLst>
                  <a:gs pos="100000">
                    <a:schemeClr val="accent5">
                      <a:lumMod val="60000"/>
                      <a:lumOff val="40000"/>
                    </a:schemeClr>
                  </a:gs>
                  <a:gs pos="0">
                    <a:schemeClr val="accent5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5EA-4DC9-BD33-13FC400311D4}"/>
              </c:ext>
            </c:extLst>
          </c:dPt>
          <c:dPt>
            <c:idx val="5"/>
            <c:bubble3D val="0"/>
            <c:spPr>
              <a:gradFill>
                <a:gsLst>
                  <a:gs pos="100000">
                    <a:schemeClr val="accent6">
                      <a:lumMod val="60000"/>
                      <a:lumOff val="40000"/>
                    </a:schemeClr>
                  </a:gs>
                  <a:gs pos="0">
                    <a:schemeClr val="accent6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5EA-4DC9-BD33-13FC400311D4}"/>
              </c:ext>
            </c:extLst>
          </c:dPt>
          <c:dPt>
            <c:idx val="6"/>
            <c:bubble3D val="0"/>
            <c:spPr>
              <a:gradFill>
                <a:gsLst>
                  <a:gs pos="100000">
                    <a:schemeClr val="accent1">
                      <a:lumMod val="60000"/>
                      <a:lumMod val="60000"/>
                      <a:lumOff val="40000"/>
                    </a:schemeClr>
                  </a:gs>
                  <a:gs pos="0">
                    <a:schemeClr val="accent1">
                      <a:lumMod val="60000"/>
                    </a:schemeClr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95EA-4DC9-BD33-13FC400311D4}"/>
              </c:ext>
            </c:extLst>
          </c:dPt>
          <c:dPt>
            <c:idx val="7"/>
            <c:bubble3D val="0"/>
            <c:spPr>
              <a:gradFill>
                <a:gsLst>
                  <a:gs pos="100000">
                    <a:schemeClr val="accent2">
                      <a:lumMod val="60000"/>
                      <a:lumMod val="60000"/>
                      <a:lumOff val="40000"/>
                    </a:schemeClr>
                  </a:gs>
                  <a:gs pos="0">
                    <a:schemeClr val="accent2">
                      <a:lumMod val="60000"/>
                    </a:schemeClr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95EA-4DC9-BD33-13FC400311D4}"/>
              </c:ext>
            </c:extLst>
          </c:dPt>
          <c:dPt>
            <c:idx val="8"/>
            <c:bubble3D val="0"/>
            <c:spPr>
              <a:gradFill>
                <a:gsLst>
                  <a:gs pos="100000">
                    <a:schemeClr val="accent3">
                      <a:lumMod val="60000"/>
                      <a:lumMod val="60000"/>
                      <a:lumOff val="40000"/>
                    </a:schemeClr>
                  </a:gs>
                  <a:gs pos="0">
                    <a:schemeClr val="accent3">
                      <a:lumMod val="60000"/>
                    </a:schemeClr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95EA-4DC9-BD33-13FC400311D4}"/>
              </c:ext>
            </c:extLst>
          </c:dPt>
          <c:dLbls>
            <c:dLbl>
              <c:idx val="0"/>
              <c:layout>
                <c:manualLayout>
                  <c:x val="3.5709036370453716E-2"/>
                  <c:y val="1.1838023558313501E-2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95EA-4DC9-BD33-13FC400311D4}"/>
                </c:ext>
              </c:extLst>
            </c:dLbl>
            <c:dLbl>
              <c:idx val="1"/>
              <c:layout>
                <c:manualLayout>
                  <c:x val="-0.14717276661544737"/>
                  <c:y val="0.13478583451350207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95EA-4DC9-BD33-13FC400311D4}"/>
                </c:ext>
              </c:extLst>
            </c:dLbl>
            <c:dLbl>
              <c:idx val="2"/>
              <c:layout>
                <c:manualLayout>
                  <c:x val="-9.1651452777869027E-2"/>
                  <c:y val="-0.17117942819778878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95EA-4DC9-BD33-13FC400311D4}"/>
                </c:ext>
              </c:extLst>
            </c:dLbl>
            <c:dLbl>
              <c:idx val="3"/>
              <c:layout>
                <c:manualLayout>
                  <c:x val="9.6064243630347795E-2"/>
                  <c:y val="-0.13637631990665361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95EA-4DC9-BD33-13FC400311D4}"/>
                </c:ext>
              </c:extLst>
            </c:dLbl>
            <c:dLbl>
              <c:idx val="4"/>
              <c:layout>
                <c:manualLayout>
                  <c:x val="-1.3709286339207613E-2"/>
                  <c:y val="6.3518219163002021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95EA-4DC9-BD33-13FC400311D4}"/>
                </c:ext>
              </c:extLst>
            </c:dLbl>
            <c:dLbl>
              <c:idx val="5"/>
              <c:layout>
                <c:manualLayout>
                  <c:x val="-3.3335975860160398E-2"/>
                  <c:y val="1.6359180268029429E-2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95EA-4DC9-BD33-13FC400311D4}"/>
                </c:ext>
              </c:extLst>
            </c:dLbl>
            <c:dLbl>
              <c:idx val="6"/>
              <c:layout>
                <c:manualLayout>
                  <c:x val="9.7297470843667588E-3"/>
                  <c:y val="4.4797798333460852E-4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95EA-4DC9-BD33-13FC400311D4}"/>
                </c:ext>
              </c:extLst>
            </c:dLbl>
            <c:dLbl>
              <c:idx val="7"/>
              <c:layout>
                <c:manualLayout>
                  <c:x val="9.2314175013837561E-3"/>
                  <c:y val="7.5085316322214737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95EA-4DC9-BD33-13FC400311D4}"/>
                </c:ext>
              </c:extLst>
            </c:dLbl>
            <c:dLbl>
              <c:idx val="8"/>
              <c:layout>
                <c:manualLayout>
                  <c:x val="5.3921974038959417E-2"/>
                  <c:y val="3.9220594114477416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95EA-4DC9-BD33-13FC400311D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dk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Revised survey table.xlsx]Sheet5'!$D$6:$D$14</c:f>
              <c:strCache>
                <c:ptCount val="9"/>
                <c:pt idx="0">
                  <c:v>Vindhyachal</c:v>
                </c:pt>
                <c:pt idx="1">
                  <c:v>Eastern plain zone</c:v>
                </c:pt>
                <c:pt idx="2">
                  <c:v>Central zone</c:v>
                </c:pt>
                <c:pt idx="3">
                  <c:v>North -Eastern Plain zone</c:v>
                </c:pt>
                <c:pt idx="4">
                  <c:v>South–Western Zone</c:v>
                </c:pt>
                <c:pt idx="5">
                  <c:v>Bundelkhand Zone</c:v>
                </c:pt>
                <c:pt idx="6">
                  <c:v>Tarai Zone</c:v>
                </c:pt>
                <c:pt idx="7">
                  <c:v>Mid -Western Zone</c:v>
                </c:pt>
                <c:pt idx="8">
                  <c:v>Western Plain zone</c:v>
                </c:pt>
              </c:strCache>
            </c:strRef>
          </c:cat>
          <c:val>
            <c:numRef>
              <c:f>'[Revised survey table.xlsx]Sheet5'!$E$6:$E$14</c:f>
              <c:numCache>
                <c:formatCode>General</c:formatCode>
                <c:ptCount val="9"/>
                <c:pt idx="0">
                  <c:v>21</c:v>
                </c:pt>
                <c:pt idx="1">
                  <c:v>153</c:v>
                </c:pt>
                <c:pt idx="2">
                  <c:v>102</c:v>
                </c:pt>
                <c:pt idx="3">
                  <c:v>79</c:v>
                </c:pt>
                <c:pt idx="4">
                  <c:v>50</c:v>
                </c:pt>
                <c:pt idx="5">
                  <c:v>32</c:v>
                </c:pt>
                <c:pt idx="6">
                  <c:v>51</c:v>
                </c:pt>
                <c:pt idx="7">
                  <c:v>29</c:v>
                </c:pt>
                <c:pt idx="8">
                  <c:v>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95EA-4DC9-BD33-13FC400311D4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zero"/>
    <c:showDLblsOverMax val="0"/>
  </c:chart>
  <c:spPr>
    <a:noFill/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/>
      <c:bar3DChart>
        <c:barDir val="col"/>
        <c:grouping val="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Potyvirus</c:v>
                </c:pt>
              </c:strCache>
            </c:strRef>
          </c:tx>
          <c:invertIfNegative val="0"/>
          <c:cat>
            <c:strRef>
              <c:f>Sheet1!$A$2:$A$15</c:f>
              <c:strCache>
                <c:ptCount val="14"/>
                <c:pt idx="0">
                  <c:v>Bottle gourd</c:v>
                </c:pt>
                <c:pt idx="1">
                  <c:v>Bitter gourd</c:v>
                </c:pt>
                <c:pt idx="2">
                  <c:v>Cucumber</c:v>
                </c:pt>
                <c:pt idx="3">
                  <c:v>Ivy gourd</c:v>
                </c:pt>
                <c:pt idx="4">
                  <c:v>Long melon</c:v>
                </c:pt>
                <c:pt idx="5">
                  <c:v>Muskmelon</c:v>
                </c:pt>
                <c:pt idx="6">
                  <c:v>Pumpkin</c:v>
                </c:pt>
                <c:pt idx="7">
                  <c:v>Ridge gourd</c:v>
                </c:pt>
                <c:pt idx="8">
                  <c:v>Round melon</c:v>
                </c:pt>
                <c:pt idx="9">
                  <c:v>Satputia</c:v>
                </c:pt>
                <c:pt idx="10">
                  <c:v>Snake gourd</c:v>
                </c:pt>
                <c:pt idx="11">
                  <c:v>Sponge gourd</c:v>
                </c:pt>
                <c:pt idx="12">
                  <c:v>Squash</c:v>
                </c:pt>
                <c:pt idx="13">
                  <c:v>Watermelon</c:v>
                </c:pt>
              </c:strCache>
            </c:strRef>
          </c:cat>
          <c:val>
            <c:numRef>
              <c:f>Sheet1!$B$2:$B$15</c:f>
              <c:numCache>
                <c:formatCode>General</c:formatCode>
                <c:ptCount val="1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0</c:v>
                </c:pt>
                <c:pt idx="6">
                  <c:v>1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A86-493E-9470-11C18C4B0E43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GMMV</c:v>
                </c:pt>
              </c:strCache>
            </c:strRef>
          </c:tx>
          <c:invertIfNegative val="0"/>
          <c:cat>
            <c:strRef>
              <c:f>Sheet1!$A$2:$A$15</c:f>
              <c:strCache>
                <c:ptCount val="14"/>
                <c:pt idx="0">
                  <c:v>Bottle gourd</c:v>
                </c:pt>
                <c:pt idx="1">
                  <c:v>Bitter gourd</c:v>
                </c:pt>
                <c:pt idx="2">
                  <c:v>Cucumber</c:v>
                </c:pt>
                <c:pt idx="3">
                  <c:v>Ivy gourd</c:v>
                </c:pt>
                <c:pt idx="4">
                  <c:v>Long melon</c:v>
                </c:pt>
                <c:pt idx="5">
                  <c:v>Muskmelon</c:v>
                </c:pt>
                <c:pt idx="6">
                  <c:v>Pumpkin</c:v>
                </c:pt>
                <c:pt idx="7">
                  <c:v>Ridge gourd</c:v>
                </c:pt>
                <c:pt idx="8">
                  <c:v>Round melon</c:v>
                </c:pt>
                <c:pt idx="9">
                  <c:v>Satputia</c:v>
                </c:pt>
                <c:pt idx="10">
                  <c:v>Snake gourd</c:v>
                </c:pt>
                <c:pt idx="11">
                  <c:v>Sponge gourd</c:v>
                </c:pt>
                <c:pt idx="12">
                  <c:v>Squash</c:v>
                </c:pt>
                <c:pt idx="13">
                  <c:v>Watermelon</c:v>
                </c:pt>
              </c:strCache>
            </c:strRef>
          </c:cat>
          <c:val>
            <c:numRef>
              <c:f>Sheet1!$C$2:$C$15</c:f>
              <c:numCache>
                <c:formatCode>General</c:formatCode>
                <c:ptCount val="1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A86-493E-9470-11C18C4B0E43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Polerovirus</c:v>
                </c:pt>
              </c:strCache>
            </c:strRef>
          </c:tx>
          <c:invertIfNegative val="0"/>
          <c:cat>
            <c:strRef>
              <c:f>Sheet1!$A$2:$A$15</c:f>
              <c:strCache>
                <c:ptCount val="14"/>
                <c:pt idx="0">
                  <c:v>Bottle gourd</c:v>
                </c:pt>
                <c:pt idx="1">
                  <c:v>Bitter gourd</c:v>
                </c:pt>
                <c:pt idx="2">
                  <c:v>Cucumber</c:v>
                </c:pt>
                <c:pt idx="3">
                  <c:v>Ivy gourd</c:v>
                </c:pt>
                <c:pt idx="4">
                  <c:v>Long melon</c:v>
                </c:pt>
                <c:pt idx="5">
                  <c:v>Muskmelon</c:v>
                </c:pt>
                <c:pt idx="6">
                  <c:v>Pumpkin</c:v>
                </c:pt>
                <c:pt idx="7">
                  <c:v>Ridge gourd</c:v>
                </c:pt>
                <c:pt idx="8">
                  <c:v>Round melon</c:v>
                </c:pt>
                <c:pt idx="9">
                  <c:v>Satputia</c:v>
                </c:pt>
                <c:pt idx="10">
                  <c:v>Snake gourd</c:v>
                </c:pt>
                <c:pt idx="11">
                  <c:v>Sponge gourd</c:v>
                </c:pt>
                <c:pt idx="12">
                  <c:v>Squash</c:v>
                </c:pt>
                <c:pt idx="13">
                  <c:v>Watermelon</c:v>
                </c:pt>
              </c:strCache>
            </c:strRef>
          </c:cat>
          <c:val>
            <c:numRef>
              <c:f>Sheet1!$D$2:$D$15</c:f>
              <c:numCache>
                <c:formatCode>General</c:formatCode>
                <c:ptCount val="14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  <c:pt idx="12">
                  <c:v>1</c:v>
                </c:pt>
                <c:pt idx="1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A86-493E-9470-11C18C4B0E43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CMV</c:v>
                </c:pt>
              </c:strCache>
            </c:strRef>
          </c:tx>
          <c:invertIfNegative val="0"/>
          <c:cat>
            <c:strRef>
              <c:f>Sheet1!$A$2:$A$15</c:f>
              <c:strCache>
                <c:ptCount val="14"/>
                <c:pt idx="0">
                  <c:v>Bottle gourd</c:v>
                </c:pt>
                <c:pt idx="1">
                  <c:v>Bitter gourd</c:v>
                </c:pt>
                <c:pt idx="2">
                  <c:v>Cucumber</c:v>
                </c:pt>
                <c:pt idx="3">
                  <c:v>Ivy gourd</c:v>
                </c:pt>
                <c:pt idx="4">
                  <c:v>Long melon</c:v>
                </c:pt>
                <c:pt idx="5">
                  <c:v>Muskmelon</c:v>
                </c:pt>
                <c:pt idx="6">
                  <c:v>Pumpkin</c:v>
                </c:pt>
                <c:pt idx="7">
                  <c:v>Ridge gourd</c:v>
                </c:pt>
                <c:pt idx="8">
                  <c:v>Round melon</c:v>
                </c:pt>
                <c:pt idx="9">
                  <c:v>Satputia</c:v>
                </c:pt>
                <c:pt idx="10">
                  <c:v>Snake gourd</c:v>
                </c:pt>
                <c:pt idx="11">
                  <c:v>Sponge gourd</c:v>
                </c:pt>
                <c:pt idx="12">
                  <c:v>Squash</c:v>
                </c:pt>
                <c:pt idx="13">
                  <c:v>Watermelon</c:v>
                </c:pt>
              </c:strCache>
            </c:strRef>
          </c:cat>
          <c:val>
            <c:numRef>
              <c:f>Sheet1!$E$2:$E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A86-493E-9470-11C18C4B0E43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Begomovirus</c:v>
                </c:pt>
              </c:strCache>
            </c:strRef>
          </c:tx>
          <c:invertIfNegative val="0"/>
          <c:cat>
            <c:strRef>
              <c:f>Sheet1!$A$2:$A$15</c:f>
              <c:strCache>
                <c:ptCount val="14"/>
                <c:pt idx="0">
                  <c:v>Bottle gourd</c:v>
                </c:pt>
                <c:pt idx="1">
                  <c:v>Bitter gourd</c:v>
                </c:pt>
                <c:pt idx="2">
                  <c:v>Cucumber</c:v>
                </c:pt>
                <c:pt idx="3">
                  <c:v>Ivy gourd</c:v>
                </c:pt>
                <c:pt idx="4">
                  <c:v>Long melon</c:v>
                </c:pt>
                <c:pt idx="5">
                  <c:v>Muskmelon</c:v>
                </c:pt>
                <c:pt idx="6">
                  <c:v>Pumpkin</c:v>
                </c:pt>
                <c:pt idx="7">
                  <c:v>Ridge gourd</c:v>
                </c:pt>
                <c:pt idx="8">
                  <c:v>Round melon</c:v>
                </c:pt>
                <c:pt idx="9">
                  <c:v>Satputia</c:v>
                </c:pt>
                <c:pt idx="10">
                  <c:v>Snake gourd</c:v>
                </c:pt>
                <c:pt idx="11">
                  <c:v>Sponge gourd</c:v>
                </c:pt>
                <c:pt idx="12">
                  <c:v>Squash</c:v>
                </c:pt>
                <c:pt idx="13">
                  <c:v>Watermelon</c:v>
                </c:pt>
              </c:strCache>
            </c:strRef>
          </c:cat>
          <c:val>
            <c:numRef>
              <c:f>Sheet1!$F$2:$F$15</c:f>
              <c:numCache>
                <c:formatCode>General</c:formatCode>
                <c:ptCount val="1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0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A86-493E-9470-11C18C4B0E43}"/>
            </c:ext>
          </c:extLst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Tospovirus</c:v>
                </c:pt>
              </c:strCache>
            </c:strRef>
          </c:tx>
          <c:invertIfNegative val="0"/>
          <c:cat>
            <c:strRef>
              <c:f>Sheet1!$A$2:$A$15</c:f>
              <c:strCache>
                <c:ptCount val="14"/>
                <c:pt idx="0">
                  <c:v>Bottle gourd</c:v>
                </c:pt>
                <c:pt idx="1">
                  <c:v>Bitter gourd</c:v>
                </c:pt>
                <c:pt idx="2">
                  <c:v>Cucumber</c:v>
                </c:pt>
                <c:pt idx="3">
                  <c:v>Ivy gourd</c:v>
                </c:pt>
                <c:pt idx="4">
                  <c:v>Long melon</c:v>
                </c:pt>
                <c:pt idx="5">
                  <c:v>Muskmelon</c:v>
                </c:pt>
                <c:pt idx="6">
                  <c:v>Pumpkin</c:v>
                </c:pt>
                <c:pt idx="7">
                  <c:v>Ridge gourd</c:v>
                </c:pt>
                <c:pt idx="8">
                  <c:v>Round melon</c:v>
                </c:pt>
                <c:pt idx="9">
                  <c:v>Satputia</c:v>
                </c:pt>
                <c:pt idx="10">
                  <c:v>Snake gourd</c:v>
                </c:pt>
                <c:pt idx="11">
                  <c:v>Sponge gourd</c:v>
                </c:pt>
                <c:pt idx="12">
                  <c:v>Squash</c:v>
                </c:pt>
                <c:pt idx="13">
                  <c:v>Watermelon</c:v>
                </c:pt>
              </c:strCache>
            </c:strRef>
          </c:cat>
          <c:val>
            <c:numRef>
              <c:f>Sheet1!$G$2:$G$15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1A86-493E-9470-11C18C4B0E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78248576"/>
        <c:axId val="78251520"/>
        <c:axId val="0"/>
      </c:bar3DChart>
      <c:catAx>
        <c:axId val="782485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0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78251520"/>
        <c:crosses val="autoZero"/>
        <c:auto val="1"/>
        <c:lblAlgn val="ctr"/>
        <c:lblOffset val="100"/>
        <c:noMultiLvlLbl val="0"/>
      </c:catAx>
      <c:valAx>
        <c:axId val="78251520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78248576"/>
        <c:crosses val="autoZero"/>
        <c:crossBetween val="between"/>
      </c:valAx>
    </c:plotArea>
    <c:legend>
      <c:legendPos val="b"/>
      <c:overlay val="0"/>
      <c:txPr>
        <a:bodyPr/>
        <a:lstStyle/>
        <a:p>
          <a:pPr>
            <a:defRPr sz="1100" b="1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0BB6-A6C7-4CBF-A516-CA2F6E61A490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9764-80F0-455C-A91D-C47BA1E7DA3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0BB6-A6C7-4CBF-A516-CA2F6E61A490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9764-80F0-455C-A91D-C47BA1E7DA3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0BB6-A6C7-4CBF-A516-CA2F6E61A490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9764-80F0-455C-A91D-C47BA1E7DA3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0BB6-A6C7-4CBF-A516-CA2F6E61A490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9764-80F0-455C-A91D-C47BA1E7DA3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0BB6-A6C7-4CBF-A516-CA2F6E61A490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9764-80F0-455C-A91D-C47BA1E7DA3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0BB6-A6C7-4CBF-A516-CA2F6E61A490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9764-80F0-455C-A91D-C47BA1E7DA3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0BB6-A6C7-4CBF-A516-CA2F6E61A490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9764-80F0-455C-A91D-C47BA1E7DA3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0BB6-A6C7-4CBF-A516-CA2F6E61A490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9764-80F0-455C-A91D-C47BA1E7DA3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0BB6-A6C7-4CBF-A516-CA2F6E61A490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9764-80F0-455C-A91D-C47BA1E7DA3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0BB6-A6C7-4CBF-A516-CA2F6E61A490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9764-80F0-455C-A91D-C47BA1E7DA3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0BB6-A6C7-4CBF-A516-CA2F6E61A490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9764-80F0-455C-A91D-C47BA1E7DA3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F0BB6-A6C7-4CBF-A516-CA2F6E61A490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89764-80F0-455C-A91D-C47BA1E7DA3F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5E2792-4AF2-4E4D-8009-AAAAC42AB1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vert="horz" lIns="91440" tIns="45720" rIns="91440" bIns="45720" rtlCol="0" anchor="ctr">
            <a:normAutofit/>
          </a:bodyPr>
          <a:lstStyle/>
          <a:p>
            <a:r>
              <a:rPr lang="en-IN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ty</a:t>
            </a:r>
            <a:r>
              <a:rPr lang="en-IN" sz="2000" b="1" dirty="0">
                <a:latin typeface="Arial" panose="020B0604020202020204" pitchFamily="34" charset="0"/>
                <a:cs typeface="Arial" panose="020B0604020202020204" pitchFamily="34" charset="0"/>
              </a:rPr>
              <a:t> Fig 1. Number of samples collected from 14 cucurbitaceous crops in Uttar Pradesh</a:t>
            </a:r>
            <a:br>
              <a:rPr lang="en-IN" sz="2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IN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20F3E761-2B26-4030-9885-98920B5FE6A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5945050"/>
              </p:ext>
            </p:extLst>
          </p:nvPr>
        </p:nvGraphicFramePr>
        <p:xfrm>
          <a:off x="1882140" y="1714500"/>
          <a:ext cx="5814060" cy="4229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4643108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466E5F4-2829-4F05-9A4E-A16B930B1C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4060455"/>
              </p:ext>
            </p:extLst>
          </p:nvPr>
        </p:nvGraphicFramePr>
        <p:xfrm>
          <a:off x="1018057" y="1450182"/>
          <a:ext cx="7098229" cy="32361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5A229D0F-C7B2-443C-994A-4294C6E6FE41}"/>
              </a:ext>
            </a:extLst>
          </p:cNvPr>
          <p:cNvSpPr/>
          <p:nvPr/>
        </p:nvSpPr>
        <p:spPr>
          <a:xfrm>
            <a:off x="1013228" y="381253"/>
            <a:ext cx="7416925" cy="76174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algn="ctr">
              <a:spcBef>
                <a:spcPct val="0"/>
              </a:spcBef>
            </a:pPr>
            <a:r>
              <a:rPr lang="en-IN" sz="2000" b="1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upplementarty</a:t>
            </a:r>
            <a:r>
              <a:rPr lang="en-IN" sz="20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Fig 2. Proportion of samples collected from 9 agroclimatic zones of Uttar Pradesh</a:t>
            </a:r>
          </a:p>
        </p:txBody>
      </p:sp>
    </p:spTree>
    <p:extLst>
      <p:ext uri="{BB962C8B-B14F-4D97-AF65-F5344CB8AC3E}">
        <p14:creationId xmlns:p14="http://schemas.microsoft.com/office/powerpoint/2010/main" val="10155124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382000" cy="114300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3. </a:t>
            </a:r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Various virus groups infecting cucurbits in Uttar Pradesh </a:t>
            </a:r>
            <a:b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aphicFrame>
        <p:nvGraphicFramePr>
          <p:cNvPr id="5" name="Chart 4"/>
          <p:cNvGraphicFramePr/>
          <p:nvPr/>
        </p:nvGraphicFramePr>
        <p:xfrm>
          <a:off x="495299" y="1281112"/>
          <a:ext cx="8420101" cy="47386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4</Words>
  <Application>Microsoft Office PowerPoint</Application>
  <PresentationFormat>On-screen Show (4:3)</PresentationFormat>
  <Paragraphs>4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Supplementarty Fig 1. Number of samples collected from 14 cucurbitaceous crops in Uttar Pradesh </vt:lpstr>
      <vt:lpstr>PowerPoint Presentation</vt:lpstr>
      <vt:lpstr>Supplementary Fig 3. Various virus groups infecting cucurbits in Uttar Pradesh  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gendran</dc:creator>
  <cp:lastModifiedBy>Nagendran K</cp:lastModifiedBy>
  <cp:revision>8</cp:revision>
  <dcterms:created xsi:type="dcterms:W3CDTF">2021-03-17T16:19:08Z</dcterms:created>
  <dcterms:modified xsi:type="dcterms:W3CDTF">2021-07-12T13:56:34Z</dcterms:modified>
</cp:coreProperties>
</file>